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6715" autoAdjust="0"/>
  </p:normalViewPr>
  <p:slideViewPr>
    <p:cSldViewPr snapToGrid="0" snapToObjects="1">
      <p:cViewPr>
        <p:scale>
          <a:sx n="100" d="100"/>
          <a:sy n="100" d="100"/>
        </p:scale>
        <p:origin x="-1000" y="3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23A4F8-3FB1-9243-9511-56B9E8A0DEF8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64D792-487F-C14C-8749-1095B94E665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87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6628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557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297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28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311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550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3056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802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198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702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9090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127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274" name="テキスト ボックス 4"/>
          <p:cNvSpPr txBox="1">
            <a:spLocks noChangeArrowheads="1"/>
          </p:cNvSpPr>
          <p:nvPr/>
        </p:nvSpPr>
        <p:spPr bwMode="auto">
          <a:xfrm>
            <a:off x="0" y="229422"/>
            <a:ext cx="919068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Times New Roman"/>
                <a:cs typeface="Times New Roman"/>
              </a:rPr>
              <a:t>Supplemental Table 2. Reproductive outcomes</a:t>
            </a:r>
            <a:endParaRPr lang="ja-JP" altLang="ja-JP" dirty="0">
              <a:latin typeface="Times New Roman"/>
              <a:cs typeface="Times New Roman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566972"/>
              </p:ext>
            </p:extLst>
          </p:nvPr>
        </p:nvGraphicFramePr>
        <p:xfrm>
          <a:off x="0" y="1066239"/>
          <a:ext cx="9144000" cy="4907811"/>
        </p:xfrm>
        <a:graphic>
          <a:graphicData uri="http://schemas.openxmlformats.org/drawingml/2006/table">
            <a:tbl>
              <a:tblPr/>
              <a:tblGrid>
                <a:gridCol w="762000"/>
                <a:gridCol w="762000"/>
                <a:gridCol w="762000"/>
                <a:gridCol w="762000"/>
                <a:gridCol w="808706"/>
                <a:gridCol w="715294"/>
                <a:gridCol w="762000"/>
                <a:gridCol w="762000"/>
                <a:gridCol w="762000"/>
                <a:gridCol w="762000"/>
                <a:gridCol w="762000"/>
                <a:gridCol w="762000"/>
              </a:tblGrid>
              <a:tr h="94380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ase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otocol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otal FSH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asal FSH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ertilization method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umber of OPU (n)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verage number of oocyte retrieved (n)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verage number of 2PN (n)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verage good quality embryo (n)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verage Endometrial thickness  of ET (mm)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umber of ET (n)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Osaka"/>
                        </a:rPr>
                        <a:t>　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egnancy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hor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.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oth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.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.8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gonis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.4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semination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7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7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.8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ong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2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.6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semination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.8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gonis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7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.7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semination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.7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gonis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.4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semination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.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gonis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4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.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semination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.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ong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15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.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CSI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gonis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7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.4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CSI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hor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7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.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oth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.7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gonis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.9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semination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.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gonis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5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.4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CSI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gonis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5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.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semination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.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.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gonis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70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.6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oth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.4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1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4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hort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50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.7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semination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.9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90" marR="6790" marT="679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9491469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1</TotalTime>
  <Words>225</Words>
  <Application>Microsoft Macintosh PowerPoint</Application>
  <PresentationFormat>画面に合わせる (4:3)</PresentationFormat>
  <Paragraphs>18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井上 治</dc:creator>
  <cp:lastModifiedBy>岩佐 尚美</cp:lastModifiedBy>
  <cp:revision>32</cp:revision>
  <cp:lastPrinted>2015-08-21T15:22:32Z</cp:lastPrinted>
  <dcterms:created xsi:type="dcterms:W3CDTF">2015-09-06T01:44:43Z</dcterms:created>
  <dcterms:modified xsi:type="dcterms:W3CDTF">2015-10-03T14:02:32Z</dcterms:modified>
</cp:coreProperties>
</file>